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72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063A255-DCA2-4EBC-93D0-D25341FD068A}" v="1" dt="2024-10-29T17:50:27.92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43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4" d="100"/>
          <a:sy n="84" d="100"/>
        </p:scale>
        <p:origin x="2202" y="9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tiana A Simao" userId="bbc116346e27cab7" providerId="LiveId" clId="{63D3CF0A-7853-4EB4-B8D1-0554790A53B4}"/>
    <pc:docChg chg="addSld delSld modSld">
      <pc:chgData name="Tatiana A Simao" userId="bbc116346e27cab7" providerId="LiveId" clId="{63D3CF0A-7853-4EB4-B8D1-0554790A53B4}" dt="2024-10-26T16:57:25.594" v="1" actId="47"/>
      <pc:docMkLst>
        <pc:docMk/>
      </pc:docMkLst>
      <pc:sldChg chg="add del">
        <pc:chgData name="Tatiana A Simao" userId="bbc116346e27cab7" providerId="LiveId" clId="{63D3CF0A-7853-4EB4-B8D1-0554790A53B4}" dt="2024-10-26T16:57:25.594" v="1" actId="47"/>
        <pc:sldMkLst>
          <pc:docMk/>
          <pc:sldMk cId="1860877272" sldId="256"/>
        </pc:sldMkLst>
      </pc:sldChg>
    </pc:docChg>
  </pc:docChgLst>
  <pc:docChgLst>
    <pc:chgData name="Tatiana A Simao" userId="bbc116346e27cab7" providerId="LiveId" clId="{9063A255-DCA2-4EBC-93D0-D25341FD068A}"/>
    <pc:docChg chg="modSld">
      <pc:chgData name="Tatiana A Simao" userId="bbc116346e27cab7" providerId="LiveId" clId="{9063A255-DCA2-4EBC-93D0-D25341FD068A}" dt="2024-10-29T17:50:32.570" v="2" actId="20577"/>
      <pc:docMkLst>
        <pc:docMk/>
      </pc:docMkLst>
      <pc:sldChg chg="addSp modSp mod">
        <pc:chgData name="Tatiana A Simao" userId="bbc116346e27cab7" providerId="LiveId" clId="{9063A255-DCA2-4EBC-93D0-D25341FD068A}" dt="2024-10-29T17:50:32.570" v="2" actId="20577"/>
        <pc:sldMkLst>
          <pc:docMk/>
          <pc:sldMk cId="547943226" sldId="272"/>
        </pc:sldMkLst>
        <pc:spChg chg="add mod">
          <ac:chgData name="Tatiana A Simao" userId="bbc116346e27cab7" providerId="LiveId" clId="{9063A255-DCA2-4EBC-93D0-D25341FD068A}" dt="2024-10-29T17:50:32.570" v="2" actId="20577"/>
          <ac:spMkLst>
            <pc:docMk/>
            <pc:sldMk cId="547943226" sldId="272"/>
            <ac:spMk id="3" creationId="{E2B44099-8F47-1145-BB9C-BD1CB7CBC897}"/>
          </ac:spMkLst>
        </pc:sp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>
            <a:extLst>
              <a:ext uri="{FF2B5EF4-FFF2-40B4-BE49-F238E27FC236}">
                <a16:creationId xmlns:a16="http://schemas.microsoft.com/office/drawing/2014/main" id="{97BA59CD-D2FA-4CB1-AF8E-23B5F209525D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37F02F60-B7EB-4DBB-A660-265EC590EE2F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3B0134-3D0A-454C-871B-C0D5FD2DDFE1}" type="datetimeFigureOut">
              <a:rPr lang="pt-BR" smtClean="0"/>
              <a:t>01/11/2024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A031EB9B-4D24-4175-BB00-054BF111D120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F22754BC-AD1E-41A6-8FEA-F16A3F3E5929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F565E9-3A7D-44FD-BA26-8AB3CEA74195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0311464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78ED56F-A311-4245-9029-F8C21214C8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36E24DE2-A091-4411-BA8F-1B86377A5A1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D22F73B1-C208-4471-9BD5-8165111FAB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23D21-4415-4367-B2B5-B1AF59EAAB3B}" type="datetimeFigureOut">
              <a:rPr lang="pt-BR" smtClean="0"/>
              <a:t>01/11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C55FA035-A598-427A-B62D-18D2C6AD0C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74D12FF1-FB02-4798-A83C-125DDDB3F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23B9C-F3B3-458C-9378-B1A8A46E030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9627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3ABA204-DEFF-410B-A7BE-5F93485A3D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B5A6F9BF-E4C2-4DF9-9BCC-DC45D9982F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7F7A7ED3-01E5-4AF3-8C2D-EC3FADB58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23D21-4415-4367-B2B5-B1AF59EAAB3B}" type="datetimeFigureOut">
              <a:rPr lang="pt-BR" smtClean="0"/>
              <a:t>01/11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441BA86-FE4A-4824-8E04-1C9997C474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CA3079B3-9D1D-4364-B628-8A57721930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23B9C-F3B3-458C-9378-B1A8A46E030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18333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B7E169B2-C0BA-455E-85E0-D9D5A16084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FD557921-7DDD-4230-A868-078D404112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BCC76C0E-833C-4370-ABAD-82CFB198B9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23D21-4415-4367-B2B5-B1AF59EAAB3B}" type="datetimeFigureOut">
              <a:rPr lang="pt-BR" smtClean="0"/>
              <a:t>01/11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73CB52A-D347-42D5-9B09-9A3499206F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953C997E-C5DF-41DE-9CE1-F73E7097B8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23B9C-F3B3-458C-9378-B1A8A46E030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47379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EE0944D-D510-452A-9AAC-E34C38B0F2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5EA8D3EE-9863-4490-88F6-C9FAA822B4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DDF08DD-D77B-48E0-ADDF-D5EBA81D27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23D21-4415-4367-B2B5-B1AF59EAAB3B}" type="datetimeFigureOut">
              <a:rPr lang="pt-BR" smtClean="0"/>
              <a:t>01/11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A1201836-E935-48ED-B84F-39B542C68C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C87F1849-E5DC-402B-8AD8-97C3ADDAE5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23B9C-F3B3-458C-9378-B1A8A46E030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52832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6E4526D-415C-4B1E-805C-CAF96ABE59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E16EB1CB-7E84-4226-A379-32AB903EF3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85C77C3C-69D2-4F63-AA8A-4CC37317C4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23D21-4415-4367-B2B5-B1AF59EAAB3B}" type="datetimeFigureOut">
              <a:rPr lang="pt-BR" smtClean="0"/>
              <a:t>01/11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E5375795-6701-4AB3-8C65-D6D6A3D17F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72E76C6-CE95-46C9-B3D9-2D1FFD1032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23B9C-F3B3-458C-9378-B1A8A46E030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564660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40BE164-2331-4EBB-AC5E-14A22B9566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57E5E801-6D3D-4754-8666-4D7C2C8030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3E8E2978-267A-40BD-AF47-CA3FDC1093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ADA36482-05F7-4F69-9353-87CE977A7C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23D21-4415-4367-B2B5-B1AF59EAAB3B}" type="datetimeFigureOut">
              <a:rPr lang="pt-BR" smtClean="0"/>
              <a:t>01/11/2024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77FCB21D-939A-4C9A-9926-B382F7E00F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E93A1722-F0D1-4869-858E-A71E21C5BA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23B9C-F3B3-458C-9378-B1A8A46E030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510214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CAEA889-BC51-4BD6-9507-EBF1B75E58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219E98FA-5365-47BF-AC90-F4F8E84C62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93B52229-FC82-4390-98E2-6683073B5F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DC60F668-3F20-4F15-B47A-F4A34C9A63B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21D71B79-0107-4862-96C9-8CE5311D1B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01151192-CB12-44C7-B7F2-1C7886697E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23D21-4415-4367-B2B5-B1AF59EAAB3B}" type="datetimeFigureOut">
              <a:rPr lang="pt-BR" smtClean="0"/>
              <a:t>01/11/2024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1142377F-08AC-40F2-B8F1-931831FD93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74CE239B-00EA-4BE0-85A9-229F0E48EC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23B9C-F3B3-458C-9378-B1A8A46E030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46328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CDAF80E-3517-489B-88CD-34E40F6F60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B4BCFD78-CFCF-4A1D-B241-A92713D43C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23D21-4415-4367-B2B5-B1AF59EAAB3B}" type="datetimeFigureOut">
              <a:rPr lang="pt-BR" smtClean="0"/>
              <a:t>01/11/2024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6FA399B6-8E3D-4158-91B4-9D9CCE149D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AD828D8B-90FC-42C3-A4B3-A48FA0FB90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23B9C-F3B3-458C-9378-B1A8A46E030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225459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B0C86B3F-8ADD-4C72-AC72-7D43DE1E0F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23D21-4415-4367-B2B5-B1AF59EAAB3B}" type="datetimeFigureOut">
              <a:rPr lang="pt-BR" smtClean="0"/>
              <a:t>01/11/2024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AA2B8621-B908-4698-BCE5-029ABC3D1B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A4CF1DDA-F264-4C0F-903D-854A0BA478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23B9C-F3B3-458C-9378-B1A8A46E030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38007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BAAED86-D50B-43CA-A237-4C1503CBF5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4201BF93-873B-4A1E-B5BF-21DEE68593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05CF9F8C-575F-41C0-BFBE-C8F1CA92EA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15667C37-1277-4C79-ABA3-D80B975722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23D21-4415-4367-B2B5-B1AF59EAAB3B}" type="datetimeFigureOut">
              <a:rPr lang="pt-BR" smtClean="0"/>
              <a:t>01/11/2024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92FCC165-B8A3-4FF2-8C99-54E35DB453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D7DA0D17-8963-44E0-97CF-F742EFBB1D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23B9C-F3B3-458C-9378-B1A8A46E030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91034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1689A97-8999-4229-9682-11BF8715B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6FB92B2C-68D0-4C5D-86F9-77CDFBDDF1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77CF0661-50D2-4ECD-BB89-A8CE86EED9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0A22991B-088F-43D6-9149-DB63171BB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23D21-4415-4367-B2B5-B1AF59EAAB3B}" type="datetimeFigureOut">
              <a:rPr lang="pt-BR" smtClean="0"/>
              <a:t>01/11/2024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D4E8901E-B586-4A0C-97CD-0C402B664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4026EA8C-9902-4B6E-AEA4-5CCFE36B1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23B9C-F3B3-458C-9378-B1A8A46E030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786193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B8092CA1-CC9C-470B-99D0-B03C0EB42E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93B171C5-E207-4D5F-BA6B-BC22B3C8DA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AF95F404-744C-4F06-B061-F81765460CA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A23D21-4415-4367-B2B5-B1AF59EAAB3B}" type="datetimeFigureOut">
              <a:rPr lang="pt-BR" smtClean="0"/>
              <a:t>01/11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AC35B9C-BA2A-4DA5-BD7E-7C311A2FBD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B45010A1-BA08-4715-B341-1C232204D6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123B9C-F3B3-458C-9378-B1A8A46E030A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35589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Agrupar 21">
            <a:extLst>
              <a:ext uri="{FF2B5EF4-FFF2-40B4-BE49-F238E27FC236}">
                <a16:creationId xmlns:a16="http://schemas.microsoft.com/office/drawing/2014/main" id="{BC3D6CEE-0C01-BB21-4521-521FF671FB42}"/>
              </a:ext>
            </a:extLst>
          </p:cNvPr>
          <p:cNvGrpSpPr/>
          <p:nvPr/>
        </p:nvGrpSpPr>
        <p:grpSpPr>
          <a:xfrm>
            <a:off x="1746685" y="320528"/>
            <a:ext cx="7154214" cy="6448859"/>
            <a:chOff x="1746685" y="320528"/>
            <a:chExt cx="7154214" cy="6448859"/>
          </a:xfrm>
        </p:grpSpPr>
        <p:pic>
          <p:nvPicPr>
            <p:cNvPr id="8" name="Imagem 7">
              <a:extLst>
                <a:ext uri="{FF2B5EF4-FFF2-40B4-BE49-F238E27FC236}">
                  <a16:creationId xmlns:a16="http://schemas.microsoft.com/office/drawing/2014/main" id="{0CAC7356-AE3C-4123-8F6F-1CC17AFEB8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-375" r="46492" b="375"/>
            <a:stretch/>
          </p:blipFill>
          <p:spPr>
            <a:xfrm>
              <a:off x="2874044" y="320528"/>
              <a:ext cx="4742239" cy="6236419"/>
            </a:xfrm>
            <a:prstGeom prst="rect">
              <a:avLst/>
            </a:prstGeom>
          </p:spPr>
        </p:pic>
        <p:grpSp>
          <p:nvGrpSpPr>
            <p:cNvPr id="21" name="Agrupar 20">
              <a:extLst>
                <a:ext uri="{FF2B5EF4-FFF2-40B4-BE49-F238E27FC236}">
                  <a16:creationId xmlns:a16="http://schemas.microsoft.com/office/drawing/2014/main" id="{3FB6CFBA-F142-3068-6129-B1263FC32625}"/>
                </a:ext>
              </a:extLst>
            </p:cNvPr>
            <p:cNvGrpSpPr/>
            <p:nvPr/>
          </p:nvGrpSpPr>
          <p:grpSpPr>
            <a:xfrm>
              <a:off x="1746685" y="6553943"/>
              <a:ext cx="7154214" cy="215444"/>
              <a:chOff x="1496165" y="6591521"/>
              <a:chExt cx="7154214" cy="215444"/>
            </a:xfrm>
          </p:grpSpPr>
          <p:sp>
            <p:nvSpPr>
              <p:cNvPr id="2" name="CaixaDeTexto 1">
                <a:extLst>
                  <a:ext uri="{FF2B5EF4-FFF2-40B4-BE49-F238E27FC236}">
                    <a16:creationId xmlns:a16="http://schemas.microsoft.com/office/drawing/2014/main" id="{B61D4DBD-09DF-5847-8AB7-A107EAFDD4F3}"/>
                  </a:ext>
                </a:extLst>
              </p:cNvPr>
              <p:cNvSpPr txBox="1"/>
              <p:nvPr/>
            </p:nvSpPr>
            <p:spPr>
              <a:xfrm>
                <a:off x="1496165" y="6591521"/>
                <a:ext cx="71542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800" dirty="0" err="1"/>
                  <a:t>Genetic</a:t>
                </a:r>
                <a:r>
                  <a:rPr lang="pt-BR" sz="800" dirty="0"/>
                  <a:t> </a:t>
                </a:r>
                <a:r>
                  <a:rPr lang="pt-BR" sz="800" dirty="0" err="1"/>
                  <a:t>Alteration</a:t>
                </a:r>
                <a:r>
                  <a:rPr lang="pt-BR" sz="800" dirty="0"/>
                  <a:t>                  </a:t>
                </a:r>
                <a:r>
                  <a:rPr lang="pt-BR" sz="800" dirty="0" err="1"/>
                  <a:t>Missense</a:t>
                </a:r>
                <a:r>
                  <a:rPr lang="pt-BR" sz="800" dirty="0"/>
                  <a:t> </a:t>
                </a:r>
                <a:r>
                  <a:rPr lang="pt-BR" sz="800" dirty="0" err="1"/>
                  <a:t>Mutation</a:t>
                </a:r>
                <a:r>
                  <a:rPr lang="pt-BR" sz="800" dirty="0"/>
                  <a:t> (</a:t>
                </a:r>
                <a:r>
                  <a:rPr lang="pt-BR" sz="800" dirty="0" err="1"/>
                  <a:t>unknown</a:t>
                </a:r>
                <a:r>
                  <a:rPr lang="pt-BR" sz="800" dirty="0"/>
                  <a:t> </a:t>
                </a:r>
                <a:r>
                  <a:rPr lang="pt-BR" sz="800" dirty="0" err="1"/>
                  <a:t>significance</a:t>
                </a:r>
                <a:r>
                  <a:rPr lang="pt-BR" sz="800" dirty="0"/>
                  <a:t>)       </a:t>
                </a:r>
                <a:r>
                  <a:rPr lang="pt-BR" sz="800" dirty="0" err="1"/>
                  <a:t>Truncating</a:t>
                </a:r>
                <a:r>
                  <a:rPr lang="pt-BR" sz="800" dirty="0"/>
                  <a:t> </a:t>
                </a:r>
                <a:r>
                  <a:rPr lang="pt-BR" sz="800" dirty="0" err="1"/>
                  <a:t>Mutation</a:t>
                </a:r>
                <a:r>
                  <a:rPr lang="pt-BR" sz="800" dirty="0"/>
                  <a:t> (</a:t>
                </a:r>
                <a:r>
                  <a:rPr lang="pt-BR" sz="800" dirty="0" err="1"/>
                  <a:t>unknown</a:t>
                </a:r>
                <a:r>
                  <a:rPr lang="pt-BR" sz="800" dirty="0"/>
                  <a:t> </a:t>
                </a:r>
                <a:r>
                  <a:rPr lang="pt-BR" sz="800" dirty="0" err="1"/>
                  <a:t>significance</a:t>
                </a:r>
                <a:r>
                  <a:rPr lang="pt-BR" sz="800" dirty="0"/>
                  <a:t>)        </a:t>
                </a:r>
                <a:r>
                  <a:rPr lang="pt-BR" sz="800" dirty="0" err="1"/>
                  <a:t>Amplification</a:t>
                </a:r>
                <a:r>
                  <a:rPr lang="pt-BR" sz="800" dirty="0"/>
                  <a:t>       </a:t>
                </a:r>
                <a:r>
                  <a:rPr lang="pt-BR" sz="800" dirty="0" err="1"/>
                  <a:t>Deletion</a:t>
                </a:r>
                <a:r>
                  <a:rPr lang="pt-BR" sz="800" dirty="0"/>
                  <a:t>        No </a:t>
                </a:r>
                <a:r>
                  <a:rPr lang="pt-BR" sz="800" dirty="0" err="1"/>
                  <a:t>alterations</a:t>
                </a:r>
                <a:r>
                  <a:rPr lang="pt-BR" sz="800" dirty="0"/>
                  <a:t> </a:t>
                </a:r>
              </a:p>
            </p:txBody>
          </p:sp>
          <p:sp>
            <p:nvSpPr>
              <p:cNvPr id="12" name="Retângulo 11">
                <a:extLst>
                  <a:ext uri="{FF2B5EF4-FFF2-40B4-BE49-F238E27FC236}">
                    <a16:creationId xmlns:a16="http://schemas.microsoft.com/office/drawing/2014/main" id="{73F8F40A-BD5F-7379-1994-6BB50CB8D534}"/>
                  </a:ext>
                </a:extLst>
              </p:cNvPr>
              <p:cNvSpPr/>
              <p:nvPr/>
            </p:nvSpPr>
            <p:spPr>
              <a:xfrm flipH="1">
                <a:off x="6602482" y="6598391"/>
                <a:ext cx="45719" cy="183943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>
                  <a:solidFill>
                    <a:srgbClr val="FF0000"/>
                  </a:solidFill>
                </a:endParaRPr>
              </a:p>
            </p:txBody>
          </p:sp>
          <p:sp>
            <p:nvSpPr>
              <p:cNvPr id="13" name="Retângulo 12">
                <a:extLst>
                  <a:ext uri="{FF2B5EF4-FFF2-40B4-BE49-F238E27FC236}">
                    <a16:creationId xmlns:a16="http://schemas.microsoft.com/office/drawing/2014/main" id="{E7878305-7531-7D23-0E68-75974F2508A4}"/>
                  </a:ext>
                </a:extLst>
              </p:cNvPr>
              <p:cNvSpPr/>
              <p:nvPr/>
            </p:nvSpPr>
            <p:spPr>
              <a:xfrm flipH="1">
                <a:off x="7303333" y="6597373"/>
                <a:ext cx="45719" cy="183943"/>
              </a:xfrm>
              <a:prstGeom prst="rect">
                <a:avLst/>
              </a:prstGeom>
              <a:ln>
                <a:solidFill>
                  <a:schemeClr val="accent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  <p:grpSp>
            <p:nvGrpSpPr>
              <p:cNvPr id="19" name="Agrupar 18">
                <a:extLst>
                  <a:ext uri="{FF2B5EF4-FFF2-40B4-BE49-F238E27FC236}">
                    <a16:creationId xmlns:a16="http://schemas.microsoft.com/office/drawing/2014/main" id="{90CC282D-3DC9-5964-8CB7-9CADA426D510}"/>
                  </a:ext>
                </a:extLst>
              </p:cNvPr>
              <p:cNvGrpSpPr/>
              <p:nvPr/>
            </p:nvGrpSpPr>
            <p:grpSpPr>
              <a:xfrm>
                <a:off x="4593980" y="6607989"/>
                <a:ext cx="46125" cy="183943"/>
                <a:chOff x="4785345" y="6597372"/>
                <a:chExt cx="46125" cy="183943"/>
              </a:xfrm>
            </p:grpSpPr>
            <p:sp>
              <p:nvSpPr>
                <p:cNvPr id="10" name="Retângulo 9">
                  <a:extLst>
                    <a:ext uri="{FF2B5EF4-FFF2-40B4-BE49-F238E27FC236}">
                      <a16:creationId xmlns:a16="http://schemas.microsoft.com/office/drawing/2014/main" id="{589E23F9-BED7-46E7-C46A-ECD2F6DE8F38}"/>
                    </a:ext>
                  </a:extLst>
                </p:cNvPr>
                <p:cNvSpPr/>
                <p:nvPr/>
              </p:nvSpPr>
              <p:spPr>
                <a:xfrm flipH="1">
                  <a:off x="4785751" y="6597372"/>
                  <a:ext cx="45719" cy="183943"/>
                </a:xfrm>
                <a:prstGeom prst="rect">
                  <a:avLst/>
                </a:prstGeom>
                <a:solidFill>
                  <a:schemeClr val="bg2">
                    <a:lumMod val="90000"/>
                  </a:schemeClr>
                </a:solidFill>
                <a:ln>
                  <a:solidFill>
                    <a:schemeClr val="bg2">
                      <a:lumMod val="9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5" name="Retângulo 14">
                  <a:extLst>
                    <a:ext uri="{FF2B5EF4-FFF2-40B4-BE49-F238E27FC236}">
                      <a16:creationId xmlns:a16="http://schemas.microsoft.com/office/drawing/2014/main" id="{A161E5DC-B235-F636-E26E-273C23867D9D}"/>
                    </a:ext>
                  </a:extLst>
                </p:cNvPr>
                <p:cNvSpPr/>
                <p:nvPr/>
              </p:nvSpPr>
              <p:spPr>
                <a:xfrm>
                  <a:off x="4785345" y="6672805"/>
                  <a:ext cx="45719" cy="45719"/>
                </a:xfrm>
                <a:prstGeom prst="rect">
                  <a:avLst/>
                </a:prstGeom>
                <a:solidFill>
                  <a:schemeClr val="bg2">
                    <a:lumMod val="50000"/>
                  </a:schemeClr>
                </a:solidFill>
                <a:ln>
                  <a:solidFill>
                    <a:schemeClr val="bg2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grpSp>
            <p:nvGrpSpPr>
              <p:cNvPr id="18" name="Agrupar 17">
                <a:extLst>
                  <a:ext uri="{FF2B5EF4-FFF2-40B4-BE49-F238E27FC236}">
                    <a16:creationId xmlns:a16="http://schemas.microsoft.com/office/drawing/2014/main" id="{0AE784B8-84D9-6C10-70F8-61AD18BCAB61}"/>
                  </a:ext>
                </a:extLst>
              </p:cNvPr>
              <p:cNvGrpSpPr/>
              <p:nvPr/>
            </p:nvGrpSpPr>
            <p:grpSpPr>
              <a:xfrm>
                <a:off x="2662331" y="6598391"/>
                <a:ext cx="46125" cy="183943"/>
                <a:chOff x="3521081" y="6601669"/>
                <a:chExt cx="46125" cy="183943"/>
              </a:xfrm>
            </p:grpSpPr>
            <p:sp>
              <p:nvSpPr>
                <p:cNvPr id="16" name="Retângulo 15">
                  <a:extLst>
                    <a:ext uri="{FF2B5EF4-FFF2-40B4-BE49-F238E27FC236}">
                      <a16:creationId xmlns:a16="http://schemas.microsoft.com/office/drawing/2014/main" id="{478F7BDE-C8ED-0071-76C4-A2DD89A01CB6}"/>
                    </a:ext>
                  </a:extLst>
                </p:cNvPr>
                <p:cNvSpPr/>
                <p:nvPr/>
              </p:nvSpPr>
              <p:spPr>
                <a:xfrm flipH="1">
                  <a:off x="3521487" y="6601669"/>
                  <a:ext cx="45719" cy="183943"/>
                </a:xfrm>
                <a:prstGeom prst="rect">
                  <a:avLst/>
                </a:prstGeom>
                <a:solidFill>
                  <a:schemeClr val="bg2">
                    <a:lumMod val="90000"/>
                  </a:schemeClr>
                </a:solidFill>
                <a:ln>
                  <a:solidFill>
                    <a:schemeClr val="bg2">
                      <a:lumMod val="9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  <p:sp>
              <p:nvSpPr>
                <p:cNvPr id="17" name="Retângulo 16">
                  <a:extLst>
                    <a:ext uri="{FF2B5EF4-FFF2-40B4-BE49-F238E27FC236}">
                      <a16:creationId xmlns:a16="http://schemas.microsoft.com/office/drawing/2014/main" id="{10BC564A-FEFA-604C-E487-D58840E84785}"/>
                    </a:ext>
                  </a:extLst>
                </p:cNvPr>
                <p:cNvSpPr/>
                <p:nvPr/>
              </p:nvSpPr>
              <p:spPr>
                <a:xfrm>
                  <a:off x="3521081" y="6677102"/>
                  <a:ext cx="45719" cy="45719"/>
                </a:xfrm>
                <a:prstGeom prst="rect">
                  <a:avLst/>
                </a:prstGeom>
                <a:solidFill>
                  <a:srgbClr val="92D050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pt-BR"/>
                </a:p>
              </p:txBody>
            </p:sp>
          </p:grpSp>
          <p:sp>
            <p:nvSpPr>
              <p:cNvPr id="20" name="Retângulo 19">
                <a:extLst>
                  <a:ext uri="{FF2B5EF4-FFF2-40B4-BE49-F238E27FC236}">
                    <a16:creationId xmlns:a16="http://schemas.microsoft.com/office/drawing/2014/main" id="{053DD906-44C4-A99F-8CB7-03484AC9B7DE}"/>
                  </a:ext>
                </a:extLst>
              </p:cNvPr>
              <p:cNvSpPr/>
              <p:nvPr/>
            </p:nvSpPr>
            <p:spPr>
              <a:xfrm flipH="1">
                <a:off x="7838047" y="6608112"/>
                <a:ext cx="45719" cy="183943"/>
              </a:xfrm>
              <a:prstGeom prst="rect">
                <a:avLst/>
              </a:prstGeom>
              <a:solidFill>
                <a:schemeClr val="bg2"/>
              </a:solidFill>
              <a:ln>
                <a:solidFill>
                  <a:schemeClr val="bg2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t-BR"/>
              </a:p>
            </p:txBody>
          </p:sp>
        </p:grpSp>
      </p:grpSp>
      <p:sp>
        <p:nvSpPr>
          <p:cNvPr id="3" name="CaixaDeTexto 2">
            <a:extLst>
              <a:ext uri="{FF2B5EF4-FFF2-40B4-BE49-F238E27FC236}">
                <a16:creationId xmlns:a16="http://schemas.microsoft.com/office/drawing/2014/main" id="{E2B44099-8F47-1145-BB9C-BD1CB7CBC897}"/>
              </a:ext>
            </a:extLst>
          </p:cNvPr>
          <p:cNvSpPr txBox="1"/>
          <p:nvPr/>
        </p:nvSpPr>
        <p:spPr>
          <a:xfrm>
            <a:off x="185194" y="62705"/>
            <a:ext cx="27557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</a:t>
            </a:r>
            <a:r>
              <a:rPr lang="en-US" b="1"/>
              <a:t>Figure S1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54794322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72</TotalTime>
  <Words>21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Pedro Nicolau</dc:creator>
  <cp:lastModifiedBy>MDPI</cp:lastModifiedBy>
  <cp:revision>65</cp:revision>
  <dcterms:created xsi:type="dcterms:W3CDTF">2022-06-08T14:29:51Z</dcterms:created>
  <dcterms:modified xsi:type="dcterms:W3CDTF">2024-11-01T07:42:15Z</dcterms:modified>
</cp:coreProperties>
</file>